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339" r:id="rId5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1991432-16D4-A338-8C74-AA5AE8E7A6BA}" name="BeKa Leuschen-Kohl" initials="BLK" userId="BeKa Leuschen-Kohl" providerId="None"/>
  <p188:author id="{152ED23C-9289-3640-DC9D-A0185063BC84}" name="Iyer-Pascuzzi, Anjali" initials="IA" userId="S::aiyerpas@purdue.edu::dcf03dc3-b88b-4fb8-8f79-4d9cab98b2b3" providerId="AD"/>
  <p188:author id="{22EA6AEE-A713-B989-205E-2187CD1F1D1A}" name="Rebecca Lynn Leuschen-kohl" initials="RL" userId="S::rleusche@purdue.edu::00225fb4-0928-44a2-820d-794618e88de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DBDBD"/>
    <a:srgbClr val="949F95"/>
    <a:srgbClr val="DEDEDE"/>
    <a:srgbClr val="ADB9CA"/>
    <a:srgbClr val="FFFFFF"/>
    <a:srgbClr val="4F4390"/>
    <a:srgbClr val="FFBDDE"/>
    <a:srgbClr val="B3B3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2" d="100"/>
          <a:sy n="72" d="100"/>
        </p:scale>
        <p:origin x="2979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ebecca Leuschen-Kohl" userId="ef62846a7a2008e6" providerId="LiveId" clId="{79E920AD-812D-4D01-830F-0FC32AD5F93C}"/>
    <pc:docChg chg="undo custSel addSld delSld">
      <pc:chgData name="Rebecca Leuschen-Kohl" userId="ef62846a7a2008e6" providerId="LiveId" clId="{79E920AD-812D-4D01-830F-0FC32AD5F93C}" dt="2024-11-05T00:53:22.059" v="8" actId="47"/>
      <pc:docMkLst>
        <pc:docMk/>
      </pc:docMkLst>
      <pc:sldChg chg="add del">
        <pc:chgData name="Rebecca Leuschen-Kohl" userId="ef62846a7a2008e6" providerId="LiveId" clId="{79E920AD-812D-4D01-830F-0FC32AD5F93C}" dt="2024-11-05T00:53:22.059" v="8" actId="47"/>
        <pc:sldMkLst>
          <pc:docMk/>
          <pc:sldMk cId="830658197" sldId="332"/>
        </pc:sldMkLst>
      </pc:sldChg>
      <pc:sldChg chg="add del">
        <pc:chgData name="Rebecca Leuschen-Kohl" userId="ef62846a7a2008e6" providerId="LiveId" clId="{79E920AD-812D-4D01-830F-0FC32AD5F93C}" dt="2024-11-05T00:53:22.059" v="8" actId="47"/>
        <pc:sldMkLst>
          <pc:docMk/>
          <pc:sldMk cId="3398032437" sldId="336"/>
        </pc:sldMkLst>
      </pc:sldChg>
      <pc:sldChg chg="add del">
        <pc:chgData name="Rebecca Leuschen-Kohl" userId="ef62846a7a2008e6" providerId="LiveId" clId="{79E920AD-812D-4D01-830F-0FC32AD5F93C}" dt="2024-11-05T00:53:22.059" v="8" actId="47"/>
        <pc:sldMkLst>
          <pc:docMk/>
          <pc:sldMk cId="3793326182" sldId="338"/>
        </pc:sldMkLst>
      </pc:sldChg>
      <pc:sldChg chg="add del">
        <pc:chgData name="Rebecca Leuschen-Kohl" userId="ef62846a7a2008e6" providerId="LiveId" clId="{79E920AD-812D-4D01-830F-0FC32AD5F93C}" dt="2024-11-05T00:53:15.299" v="5" actId="47"/>
        <pc:sldMkLst>
          <pc:docMk/>
          <pc:sldMk cId="1961722243" sldId="339"/>
        </pc:sldMkLst>
      </pc:sldChg>
      <pc:sldChg chg="add del">
        <pc:chgData name="Rebecca Leuschen-Kohl" userId="ef62846a7a2008e6" providerId="LiveId" clId="{79E920AD-812D-4D01-830F-0FC32AD5F93C}" dt="2024-11-05T00:53:22.059" v="8" actId="47"/>
        <pc:sldMkLst>
          <pc:docMk/>
          <pc:sldMk cId="2349073536" sldId="347"/>
        </pc:sldMkLst>
      </pc:sldChg>
      <pc:sldChg chg="add del">
        <pc:chgData name="Rebecca Leuschen-Kohl" userId="ef62846a7a2008e6" providerId="LiveId" clId="{79E920AD-812D-4D01-830F-0FC32AD5F93C}" dt="2024-11-05T00:53:22.059" v="8" actId="47"/>
        <pc:sldMkLst>
          <pc:docMk/>
          <pc:sldMk cId="830734933" sldId="348"/>
        </pc:sldMkLst>
      </pc:sldChg>
      <pc:sldChg chg="add del">
        <pc:chgData name="Rebecca Leuschen-Kohl" userId="ef62846a7a2008e6" providerId="LiveId" clId="{79E920AD-812D-4D01-830F-0FC32AD5F93C}" dt="2024-11-05T00:53:22.059" v="8" actId="47"/>
        <pc:sldMkLst>
          <pc:docMk/>
          <pc:sldMk cId="397969387" sldId="349"/>
        </pc:sldMkLst>
      </pc:sldChg>
      <pc:sldChg chg="add del">
        <pc:chgData name="Rebecca Leuschen-Kohl" userId="ef62846a7a2008e6" providerId="LiveId" clId="{79E920AD-812D-4D01-830F-0FC32AD5F93C}" dt="2024-11-05T00:53:22.059" v="8" actId="47"/>
        <pc:sldMkLst>
          <pc:docMk/>
          <pc:sldMk cId="1704172087" sldId="351"/>
        </pc:sldMkLst>
      </pc:sldChg>
      <pc:sldChg chg="add del">
        <pc:chgData name="Rebecca Leuschen-Kohl" userId="ef62846a7a2008e6" providerId="LiveId" clId="{79E920AD-812D-4D01-830F-0FC32AD5F93C}" dt="2024-11-05T00:53:22.059" v="8" actId="47"/>
        <pc:sldMkLst>
          <pc:docMk/>
          <pc:sldMk cId="3486478879" sldId="353"/>
        </pc:sldMkLst>
      </pc:sldChg>
      <pc:sldChg chg="add del">
        <pc:chgData name="Rebecca Leuschen-Kohl" userId="ef62846a7a2008e6" providerId="LiveId" clId="{79E920AD-812D-4D01-830F-0FC32AD5F93C}" dt="2024-11-05T00:53:22.059" v="8" actId="47"/>
        <pc:sldMkLst>
          <pc:docMk/>
          <pc:sldMk cId="2478473178" sldId="354"/>
        </pc:sldMkLst>
      </pc:sldChg>
      <pc:sldChg chg="add del">
        <pc:chgData name="Rebecca Leuschen-Kohl" userId="ef62846a7a2008e6" providerId="LiveId" clId="{79E920AD-812D-4D01-830F-0FC32AD5F93C}" dt="2024-11-05T00:53:22.059" v="8" actId="47"/>
        <pc:sldMkLst>
          <pc:docMk/>
          <pc:sldMk cId="2416863298" sldId="355"/>
        </pc:sldMkLst>
      </pc:sldChg>
      <pc:sldChg chg="add del">
        <pc:chgData name="Rebecca Leuschen-Kohl" userId="ef62846a7a2008e6" providerId="LiveId" clId="{79E920AD-812D-4D01-830F-0FC32AD5F93C}" dt="2024-11-05T00:53:22.059" v="8" actId="47"/>
        <pc:sldMkLst>
          <pc:docMk/>
          <pc:sldMk cId="568157699" sldId="356"/>
        </pc:sldMkLst>
      </pc:sldChg>
      <pc:sldChg chg="add del">
        <pc:chgData name="Rebecca Leuschen-Kohl" userId="ef62846a7a2008e6" providerId="LiveId" clId="{79E920AD-812D-4D01-830F-0FC32AD5F93C}" dt="2024-11-05T00:53:22.059" v="8" actId="47"/>
        <pc:sldMkLst>
          <pc:docMk/>
          <pc:sldMk cId="1185421222" sldId="359"/>
        </pc:sldMkLst>
      </pc:sldChg>
      <pc:sldChg chg="add del">
        <pc:chgData name="Rebecca Leuschen-Kohl" userId="ef62846a7a2008e6" providerId="LiveId" clId="{79E920AD-812D-4D01-830F-0FC32AD5F93C}" dt="2024-11-05T00:53:22.059" v="8" actId="47"/>
        <pc:sldMkLst>
          <pc:docMk/>
          <pc:sldMk cId="83140915" sldId="361"/>
        </pc:sldMkLst>
      </pc:sldChg>
      <pc:sldChg chg="add del">
        <pc:chgData name="Rebecca Leuschen-Kohl" userId="ef62846a7a2008e6" providerId="LiveId" clId="{79E920AD-812D-4D01-830F-0FC32AD5F93C}" dt="2024-11-05T00:53:22.059" v="8" actId="47"/>
        <pc:sldMkLst>
          <pc:docMk/>
          <pc:sldMk cId="58006295" sldId="363"/>
        </pc:sldMkLst>
      </pc:sldChg>
      <pc:sldChg chg="add del">
        <pc:chgData name="Rebecca Leuschen-Kohl" userId="ef62846a7a2008e6" providerId="LiveId" clId="{79E920AD-812D-4D01-830F-0FC32AD5F93C}" dt="2024-11-05T00:53:22.059" v="8" actId="47"/>
        <pc:sldMkLst>
          <pc:docMk/>
          <pc:sldMk cId="4206593612" sldId="364"/>
        </pc:sldMkLst>
      </pc:sldChg>
      <pc:sldChg chg="add del">
        <pc:chgData name="Rebecca Leuschen-Kohl" userId="ef62846a7a2008e6" providerId="LiveId" clId="{79E920AD-812D-4D01-830F-0FC32AD5F93C}" dt="2024-11-05T00:53:22.059" v="8" actId="47"/>
        <pc:sldMkLst>
          <pc:docMk/>
          <pc:sldMk cId="2301688996" sldId="365"/>
        </pc:sldMkLst>
      </pc:sldChg>
      <pc:sldChg chg="add del">
        <pc:chgData name="Rebecca Leuschen-Kohl" userId="ef62846a7a2008e6" providerId="LiveId" clId="{79E920AD-812D-4D01-830F-0FC32AD5F93C}" dt="2024-11-05T00:53:18.510" v="7" actId="47"/>
        <pc:sldMkLst>
          <pc:docMk/>
          <pc:sldMk cId="471017098" sldId="366"/>
        </pc:sldMkLst>
      </pc:sldChg>
      <pc:sldChg chg="add del">
        <pc:chgData name="Rebecca Leuschen-Kohl" userId="ef62846a7a2008e6" providerId="LiveId" clId="{79E920AD-812D-4D01-830F-0FC32AD5F93C}" dt="2024-11-05T00:53:18.081" v="6" actId="47"/>
        <pc:sldMkLst>
          <pc:docMk/>
          <pc:sldMk cId="1752517358" sldId="36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5C9A0A-66B1-4FAF-A1C5-2E9142573E35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C2AFF7-3C64-424C-82FD-976B3E97E4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7658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CC2AFF7-3C64-424C-82FD-976B3E97E48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4069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369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048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066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740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863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995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065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0355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408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6613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620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883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>
            <a:extLst>
              <a:ext uri="{FF2B5EF4-FFF2-40B4-BE49-F238E27FC236}">
                <a16:creationId xmlns:a16="http://schemas.microsoft.com/office/drawing/2014/main" id="{95D25163-0C23-407E-6318-46281CC8D2E5}"/>
              </a:ext>
            </a:extLst>
          </p:cNvPr>
          <p:cNvSpPr txBox="1"/>
          <p:nvPr/>
        </p:nvSpPr>
        <p:spPr>
          <a:xfrm>
            <a:off x="1074330" y="1502082"/>
            <a:ext cx="5623739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274012"/>
            <a:r>
              <a:rPr lang="en-US" sz="1000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7. Determination of DPI concentration sufficient to fully inhibit H7996 ROS burst in response to flg22</a:t>
            </a:r>
            <a:r>
              <a:rPr lang="en-US" sz="1000" b="1" baseline="300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to. </a:t>
            </a:r>
            <a:r>
              <a:rPr lang="en-US" sz="10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oot samples from 5-day-old tomato seedlings of H7996 were treated with 0.2 µM DPI, 0.5 µM DPI, 1 µM DPI, or mock (water) for four hours prior to 1 µM flg22</a:t>
            </a:r>
            <a:r>
              <a:rPr lang="en-US" sz="1000" baseline="300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st</a:t>
            </a:r>
            <a:r>
              <a:rPr lang="en-US" sz="10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reatment. </a:t>
            </a:r>
            <a:r>
              <a:rPr lang="en-US" sz="100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alues represent the mean ± SD from at least 6 replicates per treatment. The experiment was repeated two times with similar results. </a:t>
            </a:r>
            <a:endParaRPr lang="en-US" sz="100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Picture 5" descr="A graph of a number of lines&#10;&#10;Description automatically generated with medium confidence">
            <a:extLst>
              <a:ext uri="{FF2B5EF4-FFF2-40B4-BE49-F238E27FC236}">
                <a16:creationId xmlns:a16="http://schemas.microsoft.com/office/drawing/2014/main" id="{3CBEAAE7-34F0-C149-B109-BDFF11DF6CF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7715" y="2796996"/>
            <a:ext cx="4993918" cy="24969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17222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56102D0D35E964BBFE2C79D04696EE4" ma:contentTypeVersion="18" ma:contentTypeDescription="Create a new document." ma:contentTypeScope="" ma:versionID="71fc2afbc31600472ab73e35b249ead8">
  <xsd:schema xmlns:xsd="http://www.w3.org/2001/XMLSchema" xmlns:xs="http://www.w3.org/2001/XMLSchema" xmlns:p="http://schemas.microsoft.com/office/2006/metadata/properties" xmlns:ns2="974c5d5a-69c4-47c0-8134-bb286fa4472c" xmlns:ns3="746cde4b-492d-48ba-92d7-9676a22a1012" targetNamespace="http://schemas.microsoft.com/office/2006/metadata/properties" ma:root="true" ma:fieldsID="23e452dd77b66b46fbeaa7a26eb6c6ab" ns2:_="" ns3:_="">
    <xsd:import namespace="974c5d5a-69c4-47c0-8134-bb286fa4472c"/>
    <xsd:import namespace="746cde4b-492d-48ba-92d7-9676a22a101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Location" minOccurs="0"/>
                <xsd:element ref="ns2:lcf76f155ced4ddcb4097134ff3c332f" minOccurs="0"/>
                <xsd:element ref="ns3:TaxCatchAll" minOccurs="0"/>
                <xsd:element ref="ns2:MediaLengthInSeconds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74c5d5a-69c4-47c0-8134-bb286fa4472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8e9e90a8-b24c-4be7-8760-a88b2cd47eb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46cde4b-492d-48ba-92d7-9676a22a1012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f532aa21-857b-4867-95d0-9dc152152f45}" ma:internalName="TaxCatchAll" ma:showField="CatchAllData" ma:web="746cde4b-492d-48ba-92d7-9676a22a101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974c5d5a-69c4-47c0-8134-bb286fa4472c">
      <Terms xmlns="http://schemas.microsoft.com/office/infopath/2007/PartnerControls"/>
    </lcf76f155ced4ddcb4097134ff3c332f>
    <TaxCatchAll xmlns="746cde4b-492d-48ba-92d7-9676a22a1012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34E92243-6744-4250-8C81-06A634B89881}">
  <ds:schemaRefs>
    <ds:schemaRef ds:uri="746cde4b-492d-48ba-92d7-9676a22a1012"/>
    <ds:schemaRef ds:uri="974c5d5a-69c4-47c0-8134-bb286fa4472c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5313B5D3-9FE6-4906-868D-5CC357E257CA}">
  <ds:schemaRefs>
    <ds:schemaRef ds:uri="http://purl.org/dc/elements/1.1/"/>
    <ds:schemaRef ds:uri="http://schemas.openxmlformats.org/package/2006/metadata/core-properties"/>
    <ds:schemaRef ds:uri="http://purl.org/dc/terms/"/>
    <ds:schemaRef ds:uri="http://www.w3.org/XML/1998/namespace"/>
    <ds:schemaRef ds:uri="http://schemas.microsoft.com/office/2006/metadata/properties"/>
    <ds:schemaRef ds:uri="http://schemas.microsoft.com/office/2006/documentManagement/types"/>
    <ds:schemaRef ds:uri="746cde4b-492d-48ba-92d7-9676a22a1012"/>
    <ds:schemaRef ds:uri="http://purl.org/dc/dcmitype/"/>
    <ds:schemaRef ds:uri="http://schemas.microsoft.com/office/infopath/2007/PartnerControls"/>
    <ds:schemaRef ds:uri="974c5d5a-69c4-47c0-8134-bb286fa4472c"/>
  </ds:schemaRefs>
</ds:datastoreItem>
</file>

<file path=customXml/itemProps3.xml><?xml version="1.0" encoding="utf-8"?>
<ds:datastoreItem xmlns:ds="http://schemas.openxmlformats.org/officeDocument/2006/customXml" ds:itemID="{986C45CB-9F98-4FBA-95D4-669FBCC50C6D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83</Words>
  <Application>Microsoft Office PowerPoint</Application>
  <PresentationFormat>Custom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2013 - 2022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!</dc:title>
  <dc:creator>BeKa Leuschen</dc:creator>
  <cp:lastModifiedBy>BeKa Leuschen-Kohl</cp:lastModifiedBy>
  <cp:revision>1</cp:revision>
  <dcterms:created xsi:type="dcterms:W3CDTF">2022-01-14T17:50:55Z</dcterms:created>
  <dcterms:modified xsi:type="dcterms:W3CDTF">2024-11-05T00:53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56102D0D35E964BBFE2C79D04696EE4</vt:lpwstr>
  </property>
  <property fmtid="{D5CDD505-2E9C-101B-9397-08002B2CF9AE}" pid="3" name="MediaServiceImageTags">
    <vt:lpwstr/>
  </property>
  <property fmtid="{D5CDD505-2E9C-101B-9397-08002B2CF9AE}" pid="4" name="MSIP_Label_4044bd30-2ed7-4c9d-9d12-46200872a97b_Enabled">
    <vt:lpwstr>true</vt:lpwstr>
  </property>
  <property fmtid="{D5CDD505-2E9C-101B-9397-08002B2CF9AE}" pid="5" name="MSIP_Label_4044bd30-2ed7-4c9d-9d12-46200872a97b_SetDate">
    <vt:lpwstr>2022-12-15T15:50:22Z</vt:lpwstr>
  </property>
  <property fmtid="{D5CDD505-2E9C-101B-9397-08002B2CF9AE}" pid="6" name="MSIP_Label_4044bd30-2ed7-4c9d-9d12-46200872a97b_Method">
    <vt:lpwstr>Standard</vt:lpwstr>
  </property>
  <property fmtid="{D5CDD505-2E9C-101B-9397-08002B2CF9AE}" pid="7" name="MSIP_Label_4044bd30-2ed7-4c9d-9d12-46200872a97b_Name">
    <vt:lpwstr>defa4170-0d19-0005-0004-bc88714345d2</vt:lpwstr>
  </property>
  <property fmtid="{D5CDD505-2E9C-101B-9397-08002B2CF9AE}" pid="8" name="MSIP_Label_4044bd30-2ed7-4c9d-9d12-46200872a97b_SiteId">
    <vt:lpwstr>4130bd39-7c53-419c-b1e5-8758d6d63f21</vt:lpwstr>
  </property>
  <property fmtid="{D5CDD505-2E9C-101B-9397-08002B2CF9AE}" pid="9" name="MSIP_Label_4044bd30-2ed7-4c9d-9d12-46200872a97b_ActionId">
    <vt:lpwstr>f1376b59-ccc7-4a7c-91ca-02a5a8238883</vt:lpwstr>
  </property>
  <property fmtid="{D5CDD505-2E9C-101B-9397-08002B2CF9AE}" pid="10" name="MSIP_Label_4044bd30-2ed7-4c9d-9d12-46200872a97b_ContentBits">
    <vt:lpwstr>0</vt:lpwstr>
  </property>
</Properties>
</file>